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3" r:id="rId3"/>
    <p:sldId id="257" r:id="rId4"/>
    <p:sldId id="258" r:id="rId5"/>
    <p:sldId id="260" r:id="rId6"/>
    <p:sldId id="261" r:id="rId7"/>
    <p:sldId id="262" r:id="rId8"/>
  </p:sldIdLst>
  <p:sldSz cx="9144000" cy="6858000" type="screen4x3"/>
  <p:notesSz cx="6858000" cy="9144000"/>
  <p:custDataLst>
    <p:tags r:id="rId12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66" d="100"/>
          <a:sy n="66" d="100"/>
        </p:scale>
        <p:origin x="1280" y="3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presProps" Target="presProps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2" Type="http://schemas.openxmlformats.org/officeDocument/2006/relationships/tags" Target="tags/tag1.xml"/><Relationship Id="rId11" Type="http://schemas.openxmlformats.org/officeDocument/2006/relationships/tableStyles" Target="tableStyles.xml"/><Relationship Id="rId10" Type="http://schemas.openxmlformats.org/officeDocument/2006/relationships/viewProps" Target="viewProps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/>
          <p:cNvSpPr>
            <a:spLocks noGrp="1"/>
          </p:cNvSpPr>
          <p:nvPr>
            <p:ph type="title"/>
          </p:nvPr>
        </p:nvSpPr>
        <p:spPr>
          <a:xfrm>
            <a:off x="323528" y="-27384"/>
            <a:ext cx="6804248" cy="562074"/>
          </a:xfrm>
        </p:spPr>
        <p:txBody>
          <a:bodyPr>
            <a:normAutofit/>
          </a:bodyPr>
          <a:lstStyle/>
          <a:p>
            <a:pPr algn="l" fontAlgn="auto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imers used in this study.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表格 4"/>
          <p:cNvGraphicFramePr>
            <a:graphicFrameLocks noGrp="1"/>
          </p:cNvGraphicFramePr>
          <p:nvPr/>
        </p:nvGraphicFramePr>
        <p:xfrm>
          <a:off x="323528" y="476672"/>
          <a:ext cx="8568952" cy="633669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304256"/>
                <a:gridCol w="4824537"/>
                <a:gridCol w="1440159"/>
              </a:tblGrid>
              <a:tr h="372747"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me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e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XB2 location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2747"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T primer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372747"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5073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CCACACAATCATCACCTGCC-3′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73-5092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</a:tr>
              <a:tr h="372747"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plification primers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</a:tr>
              <a:tr h="372747"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-F1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TTGGAAATGTGGAAAGGAAGGAC-3′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8-2050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</a:tr>
              <a:tr h="372747"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T-R1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CTGTATTTCTGCTATTAAGTCTTTTGATGGG-3′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09-3539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</a:tr>
              <a:tr h="372747"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-F2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CAGAGCCAACAGCCCCACCA-3′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47-2166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</a:tr>
              <a:tr h="372747"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T-R2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CTGCCAGTTCTAGCTCTGCTTC-3′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41-3462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</a:tr>
              <a:tr h="372747"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ing primers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</a:tr>
              <a:tr h="372747"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1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CACTCTTTGGCAACGACCC-3′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60-2278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</a:tr>
              <a:tr h="372747"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3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AATTGGGCCTGAAAATCC-3′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94-2711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</a:tr>
              <a:tr h="372747"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2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GGATTTTCAGGCCCAATT-3′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00-2618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</a:tr>
              <a:tr h="372747"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4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GGAATATTGCTGGTGATCC-3′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14-3033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</a:tr>
              <a:tr h="372747"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2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GTTGACTCAGATTGGTTG-3’ 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19-2537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</a:tr>
              <a:tr h="372747"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4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TGGAGAAAATTAGTAGATTT-3′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60-2780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</a:tr>
              <a:tr h="372747"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1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ATAAAACCTCCAATTCC-3′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96-2413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</a:tr>
              <a:tr h="372747"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3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′-CTGTCCTTTTTCTTTAT-3′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36-2753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0" y="44624"/>
            <a:ext cx="8229600" cy="562074"/>
          </a:xfrm>
        </p:spPr>
        <p:txBody>
          <a:bodyPr>
            <a:normAutofit/>
          </a:bodyPr>
          <a:lstStyle/>
          <a:p>
            <a:pPr algn="l" fontAlgn="auto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2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atment regimens in t</a:t>
            </a:r>
            <a:r>
              <a:rPr lang="en-US" altLang="zh-CN" sz="1600" dirty="0">
                <a:solidFill>
                  <a:srgbClr val="000000"/>
                </a:solidFill>
                <a:latin typeface="Times New Roman" panose="02020603050405020304"/>
              </a:rPr>
              <a:t>reatment-experienced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.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179512" y="692696"/>
          <a:ext cx="6768753" cy="596033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88232"/>
                <a:gridCol w="1656185"/>
                <a:gridCol w="1584176"/>
                <a:gridCol w="1440160"/>
              </a:tblGrid>
              <a:tr h="37252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Sample cod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RTIs treatment histor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NRTIs treatment histor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PIs treatment histor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19-63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</a:t>
                      </a:r>
                      <a:r>
                        <a:rPr lang="en-US" sz="1100" b="0" i="0" u="none" strike="noStrike" baseline="0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,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LPV/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69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70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72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,D4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,NV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72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AZT/3TC ,DDI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V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75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,AZ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LPV/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77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,AZ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,NV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79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,NV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80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</a:t>
                      </a:r>
                      <a:r>
                        <a:rPr lang="en-US" sz="1100" b="0" i="0" u="none" strike="noStrike" baseline="0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 T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DF,D4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V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81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,AZ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,NV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84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,AZ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LPV/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85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,AZ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V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92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,AB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LPV/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93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kern="1200" dirty="0">
                          <a:solidFill>
                            <a:srgbClr val="000000"/>
                          </a:solidFill>
                          <a:latin typeface="Times New Roman" panose="02020603050405020304"/>
                          <a:ea typeface="+mn-ea"/>
                          <a:cs typeface="+mn-cs"/>
                        </a:rPr>
                        <a:t>HIVHN2020-933</a:t>
                      </a:r>
                      <a:endParaRPr lang="en-US" sz="1200" b="0" i="0" u="none" strike="noStrike" kern="1200" dirty="0">
                        <a:solidFill>
                          <a:srgbClr val="000000"/>
                        </a:solidFill>
                        <a:latin typeface="Times New Roman" panose="02020603050405020304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,D4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latin typeface="Times New Roman" panose="02020603050405020304"/>
                          <a:ea typeface="+mn-ea"/>
                          <a:cs typeface="+mn-cs"/>
                        </a:rPr>
                        <a:t>EFV,NVP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latin typeface="Times New Roman" panose="02020603050405020304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latin typeface="Times New Roman" panose="02020603050405020304"/>
                          <a:ea typeface="+mn-ea"/>
                          <a:cs typeface="+mn-cs"/>
                        </a:rPr>
                        <a:t>LPV/r</a:t>
                      </a:r>
                      <a:endParaRPr lang="en-US" sz="1100" b="0" i="0" u="none" strike="noStrike" kern="1200" dirty="0">
                        <a:solidFill>
                          <a:srgbClr val="000000"/>
                        </a:solidFill>
                        <a:latin typeface="Times New Roman" panose="02020603050405020304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179512" y="116632"/>
          <a:ext cx="6768753" cy="670537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88232"/>
                <a:gridCol w="1656185"/>
                <a:gridCol w="1584176"/>
                <a:gridCol w="1440160"/>
              </a:tblGrid>
              <a:tr h="37252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Sample cod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RTIs treatment histor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NRTIs treatment history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PIs treatment histor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94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94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94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94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95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95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AB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LPV/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99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99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10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AZT,3T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V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LPV/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,DDI,D4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V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1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2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2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AZT,3T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LPV/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179512" y="116632"/>
          <a:ext cx="6696745" cy="670537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16224"/>
                <a:gridCol w="1656185"/>
                <a:gridCol w="1584176"/>
                <a:gridCol w="1440160"/>
              </a:tblGrid>
              <a:tr h="37252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Sample cod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RTIs treatment histor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NRTIs treatment history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PIs treatment histor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3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3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AZT,3T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3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AZT,3TC,AB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V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LPV/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4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4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ABC,3T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4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,AZ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LPV/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4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,AZ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LPV/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1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AZT,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LPV/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10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LPV/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11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,D4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LPV/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12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12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,TAF/FT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33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33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,AZ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33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AZT,3T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34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19-SF69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AZT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V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LPV/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179512" y="116632"/>
          <a:ext cx="6768753" cy="670537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88232"/>
                <a:gridCol w="1656185"/>
                <a:gridCol w="1584176"/>
                <a:gridCol w="1440160"/>
              </a:tblGrid>
              <a:tr h="37252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Sample cod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RTIs treatment histor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NRTIs treatment history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PIs treatment histor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19-SF74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SF124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TDF/FT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SF135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LPV/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SF136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LPV/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SF141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SF3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AZT,3T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SF4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SF4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LPV/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kern="1200" dirty="0">
                          <a:solidFill>
                            <a:srgbClr val="000000"/>
                          </a:solidFill>
                          <a:latin typeface="Times New Roman" panose="02020603050405020304"/>
                          <a:ea typeface="+mn-ea"/>
                          <a:cs typeface="+mn-cs"/>
                        </a:rPr>
                        <a:t>HIVHN2020-721</a:t>
                      </a:r>
                      <a:endParaRPr lang="en-US" sz="1200" b="0" i="0" u="none" strike="noStrike" kern="1200" dirty="0">
                        <a:solidFill>
                          <a:srgbClr val="000000"/>
                        </a:solidFill>
                        <a:latin typeface="Times New Roman" panose="02020603050405020304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DDI,AZT  3TC,AB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r>
                        <a:rPr lang="en-US" sz="1200" b="0" i="0" u="none" strike="noStrike" kern="1200">
                          <a:solidFill>
                            <a:srgbClr val="000000"/>
                          </a:solidFill>
                          <a:latin typeface="Times New Roman" panose="02020603050405020304"/>
                          <a:ea typeface="+mn-ea"/>
                          <a:cs typeface="+mn-cs"/>
                        </a:rPr>
                        <a:t>NVP</a:t>
                      </a:r>
                      <a:endParaRPr lang="en-US" sz="1200" b="0" i="0" u="none" strike="noStrike" kern="1200">
                        <a:solidFill>
                          <a:srgbClr val="000000"/>
                        </a:solidFill>
                        <a:latin typeface="Times New Roman" panose="02020603050405020304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fontAlgn="ctr" latinLnBrk="0" hangingPunct="1"/>
                      <a:r>
                        <a:rPr lang="en-US" sz="1200" b="0" i="0" u="none" strike="noStrike" kern="1200" dirty="0">
                          <a:solidFill>
                            <a:srgbClr val="000000"/>
                          </a:solidFill>
                          <a:latin typeface="Times New Roman" panose="02020603050405020304"/>
                          <a:ea typeface="+mn-ea"/>
                          <a:cs typeface="+mn-cs"/>
                        </a:rPr>
                        <a:t>LPV/r</a:t>
                      </a:r>
                      <a:endParaRPr lang="en-US" sz="1200" b="0" i="0" u="none" strike="noStrike" kern="1200" dirty="0">
                        <a:solidFill>
                          <a:srgbClr val="000000"/>
                        </a:solidFill>
                        <a:latin typeface="Times New Roman" panose="02020603050405020304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75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AZT,3T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V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83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AZT,DDI,3TC,TAF/FT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LPV/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86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D4T,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V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88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AZT,DDI,3T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V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LPV/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95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95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,TAF/FT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98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0-99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179512" y="116632"/>
          <a:ext cx="6696745" cy="484277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16224"/>
                <a:gridCol w="1656185"/>
                <a:gridCol w="1584176"/>
                <a:gridCol w="1440160"/>
              </a:tblGrid>
              <a:tr h="37252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Sample cod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RTIs treatment histor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NRTIs treatment history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PIs treatment history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,RPV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2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AZT,3T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4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TDF,3T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V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10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AZT/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VP,EFV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10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11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11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AZT,DDI,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LPV/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11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11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AZT,3T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V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LPV/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11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NV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LPV/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33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D4T,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</a:tr>
              <a:tr h="372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HIVHN2021-34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3TC,TDF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Times New Roman" panose="02020603050405020304"/>
                        </a:rPr>
                        <a:t>EFV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latin typeface="Times New Roman" panose="02020603050405020304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ZjQxYTllMzRiZmE0ZTFhMTVmYTM4YjcxMjU3MWY2ZmEifQ=="/>
  <p:tag name="commondata" val="eyJoZGlkIjoiN2Y5OWYwMTI0NGQxYzExZjYwZjQ4ODc2MDRiOWQyNDc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18</Words>
  <Application>WPS 演示</Application>
  <PresentationFormat>全屏显示(4:3)</PresentationFormat>
  <Paragraphs>624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5" baseType="lpstr">
      <vt:lpstr>Arial</vt:lpstr>
      <vt:lpstr>宋体</vt:lpstr>
      <vt:lpstr>Wingdings</vt:lpstr>
      <vt:lpstr>Times New Roman</vt:lpstr>
      <vt:lpstr>Times New Roman</vt:lpstr>
      <vt:lpstr>微软雅黑</vt:lpstr>
      <vt:lpstr>Arial Unicode MS</vt:lpstr>
      <vt:lpstr>Calibri</vt:lpstr>
      <vt:lpstr>Office 主题</vt:lpstr>
      <vt:lpstr>Supplementary Table 1 Primers used in this study.</vt:lpstr>
      <vt:lpstr>Supplementary Table 2 Treatment regimens in treatment-experienced patients.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Table 1 Treatment regimens in treatment-experienced patients</dc:title>
  <dc:creator>Administrator</dc:creator>
  <cp:lastModifiedBy>霍玉奇</cp:lastModifiedBy>
  <cp:revision>17</cp:revision>
  <dcterms:created xsi:type="dcterms:W3CDTF">2022-07-21T08:17:00Z</dcterms:created>
  <dcterms:modified xsi:type="dcterms:W3CDTF">2023-11-25T01:32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C1D78056F8924C3C906E80A87EDA59B6</vt:lpwstr>
  </property>
  <property fmtid="{D5CDD505-2E9C-101B-9397-08002B2CF9AE}" pid="3" name="KSOProductBuildVer">
    <vt:lpwstr>2052-12.1.0.15712</vt:lpwstr>
  </property>
</Properties>
</file>